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0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306461-F5BD-4DBE-B228-A745BB9E29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A4FCCB-9FAB-46F6-9531-719AD5B606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CC6ED5-6213-4785-814C-EE1C0FC54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980BA6-AC92-48B9-BDC0-05BD92172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01A6F-F15C-421D-B3B3-B574E8741C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46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977DF-6E06-43D4-A12D-2987993AC0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A92098-FF29-4020-83BA-C5531F7879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2EAB53-4791-4D2D-9E45-A6C729A87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6F43F4-3981-4F41-BD8C-0A20A0402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D9D958-5DA0-4A83-AEFA-2F13D3A4A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392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6F7822-725B-47C1-824F-B02BECA0A0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565C86-691D-4394-8DC2-43D6B9B5EA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DA7531-BDD3-4A0D-9ABD-7A5D04EAA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E3DEDE-2D39-4A2E-B4EF-597E32316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8CFD0E-CFEE-4398-B1D4-2CB143AD29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390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93FC75-1DAE-4F75-A34A-E0049D4561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011F1B-1B0C-40D2-81BF-FD85A548B1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4CA2BD-0DBE-450A-91DF-DDF49CF5C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459B19-8B42-4FD9-8E2A-7858B03FC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89466C-966D-47A0-9058-54FCA2D3C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81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F5F25F-1741-48C5-BFA2-2E562C115E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0F1534-8435-4BE3-987D-BF32C7168D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19BE65-4182-4122-AE5C-74EF9A339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6B4D0F-8360-40DA-8EC1-578202647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7A76D4-B270-4352-8F97-B82EC5F0D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469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09078F-A9F2-4E22-B5C7-E635620DCB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B45D72-95B4-414F-B658-B61BD0E75A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2AA75D-AC70-455A-8A01-A60FFD67F8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9C11D3-1ED6-415D-91BD-62492B4FF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FA43CC-E2E5-429F-A119-3E62003D1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55679F-C669-4BE4-83D7-A918AD5D7E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593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2A8626-A5BF-4E6C-998E-0BD5A677D0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C5DAD4-978E-4AFF-9184-81573566CB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D9EF3E-F535-4FB6-A938-B35F59CC34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2C212F6-3D9D-4B7C-B1F6-9192BF770D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0ED6CEA-4FB7-48AB-AFAC-1BA91828DF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FA4D43-5620-4183-95C9-7F679816A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631282-F0A4-4DBC-A425-80876316E3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16517A7-D844-4A9E-9706-9D66ABEBE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036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5A3858-8A11-4DE3-872F-C545BA09B2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141596-69C8-48D5-A300-A6112DC3D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53F6BE2-F8A6-4C40-90F9-4517545F3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ED362DA-1C17-40F1-A079-942696C79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375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2461EC-CEE5-4B6B-9D9A-DFBA3344C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E0F42EF-0FC1-4B2E-A4FC-08080BEBD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F6FB96B-51C0-468D-A90B-F4D618D72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279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CEFA3-BB7E-4238-B80A-F2C467B9DF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AA107A-AB8A-4146-8B07-A19ADB41DC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A6E254-A841-4461-9A3B-F3ED4E487F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F4B86E-9F79-4A8D-A596-01C9246318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F12547-BA1F-4D74-9B85-416C0C13C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68FACF-B388-4B96-8514-7F85CE4E9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310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153F5-6BD4-4574-8F61-F5DEEFFE03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2A0AB46-5B7D-493D-B726-72F458DD8B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CAC9C1-C6B4-4469-8848-E10959B5B7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97120F-FDC2-42BE-89F0-264F148B8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6BB65D-947A-46DC-94D8-72257C81B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0E4BBB-5373-4F67-AABA-B158068A63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182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91011EE-076D-4565-8C80-C93823C454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855620-8384-48D8-98DB-8BA553FA4E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EAEAC-D53C-4464-8337-6A18863946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B3E4B-7C0B-41C5-987A-A604AA08CD81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61328A-0E9B-453C-8072-62D514537F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593422-7BF8-43F9-A19A-7A9B85D8B6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C838CF-753C-449E-8C09-D66775CE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492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>
            <a:extLst>
              <a:ext uri="{FF2B5EF4-FFF2-40B4-BE49-F238E27FC236}">
                <a16:creationId xmlns:a16="http://schemas.microsoft.com/office/drawing/2014/main" id="{86E99FD2-0892-4B01-9960-577FE4937E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214142" y="769545"/>
            <a:ext cx="7763715" cy="380198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9D20159-E3B4-4C64-BD1D-55D8B8F93187}"/>
              </a:ext>
            </a:extLst>
          </p:cNvPr>
          <p:cNvSpPr/>
          <p:nvPr/>
        </p:nvSpPr>
        <p:spPr>
          <a:xfrm>
            <a:off x="983810" y="4913830"/>
            <a:ext cx="1028775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1. mRNA expression of EMT markers (CDH1, CDH2, VIM) and transcription factors (SNAI2, TWIST, ZEB1, ZEB2). n = 4 and data represent mean </a:t>
            </a:r>
            <a:r>
              <a:rPr lang="en-US" b="1"/>
              <a:t>± sem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741473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woo Kang</dc:creator>
  <cp:lastModifiedBy>Minwoo Kang</cp:lastModifiedBy>
  <cp:revision>1</cp:revision>
  <dcterms:created xsi:type="dcterms:W3CDTF">2024-09-26T17:49:36Z</dcterms:created>
  <dcterms:modified xsi:type="dcterms:W3CDTF">2024-09-26T17:50:17Z</dcterms:modified>
</cp:coreProperties>
</file>